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C75CBB-1157-40F9-AFF8-8E83DF54C446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58D1B7-231B-4C77-9CA4-7C508C34A9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43467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 smtClean="0"/>
              <a:t>Supplementary </a:t>
            </a:r>
            <a:r>
              <a:rPr lang="en-CA" smtClean="0"/>
              <a:t>Figure </a:t>
            </a:r>
            <a:r>
              <a:rPr lang="en-CA" smtClean="0"/>
              <a:t>6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CC88B7-DE8F-450E-A02D-FEED2AE35043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449805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34710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84212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06331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34356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15442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97325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25474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9341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16703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00868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4117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71161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2381" y="1790278"/>
            <a:ext cx="1990149" cy="21421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 descr="T:\Transfer\Cindy\Old-Folders\For-Jane\PROTECT2\Validation\Test-of-Tests\No-Chemo\All\2015-08-31_TEAM-TOT_KM-Validation_DRFS_Oncotype-DX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4254" y="1800451"/>
            <a:ext cx="1831785" cy="19717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T:\Transfer\Cindy\Old-Folders\For-Jane\PROTECT2\Validation\Test-of-Tests\No-Chemo\All\2015-08-31_TEAM-TOT_KM-Validation_DRFS_MammaPrint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708" y="4355976"/>
            <a:ext cx="1849244" cy="19905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4" descr="T:\Transfer\Cindy\Old-Folders\For-Jane\PROTECT2\Validation\Test-of-Tests\No-Chemo\All\2015-08-31_TEAM-TOT_KM-Validation_DRFS_GGI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2615" y="4362625"/>
            <a:ext cx="1857673" cy="19995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4936756" y="1602521"/>
            <a:ext cx="17366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>
                <a:latin typeface="Arial Narrow" panose="020B0606020202030204" pitchFamily="34" charset="0"/>
              </a:rPr>
              <a:t>OncotypeDx-25-</a:t>
            </a:r>
            <a:r>
              <a:rPr lang="en-CA" sz="1400" i="1" dirty="0" smtClean="0">
                <a:latin typeface="Arial Narrow" panose="020B0606020202030204" pitchFamily="34" charset="0"/>
              </a:rPr>
              <a:t>like</a:t>
            </a:r>
            <a:endParaRPr lang="en-CA" sz="1400" i="1" dirty="0">
              <a:latin typeface="Arial Narrow" panose="020B060602020203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66018" y="4140126"/>
            <a:ext cx="1546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err="1" smtClean="0">
                <a:latin typeface="Arial Narrow" panose="020B0606020202030204" pitchFamily="34" charset="0"/>
              </a:rPr>
              <a:t>MammaPrint</a:t>
            </a:r>
            <a:r>
              <a:rPr lang="en-CA" sz="1400" dirty="0" smtClean="0">
                <a:latin typeface="Arial Narrow" panose="020B0606020202030204" pitchFamily="34" charset="0"/>
              </a:rPr>
              <a:t>-</a:t>
            </a:r>
            <a:r>
              <a:rPr lang="en-CA" sz="1400" i="1" dirty="0" smtClean="0">
                <a:latin typeface="Arial Narrow" panose="020B0606020202030204" pitchFamily="34" charset="0"/>
              </a:rPr>
              <a:t>like</a:t>
            </a:r>
            <a:endParaRPr lang="en-CA" sz="1400" i="1" dirty="0">
              <a:latin typeface="Arial Narrow" panose="020B060602020203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462615" y="4135182"/>
            <a:ext cx="22209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>
                <a:latin typeface="Arial Narrow" panose="020B0606020202030204" pitchFamily="34" charset="0"/>
              </a:rPr>
              <a:t>Genomic Grade Index-</a:t>
            </a:r>
            <a:r>
              <a:rPr lang="en-CA" sz="1400" i="1" dirty="0" smtClean="0">
                <a:latin typeface="Arial Narrow" panose="020B0606020202030204" pitchFamily="34" charset="0"/>
              </a:rPr>
              <a:t>like</a:t>
            </a:r>
            <a:endParaRPr lang="en-CA" sz="1400" i="1" dirty="0">
              <a:latin typeface="Arial Narrow" panose="020B0606020202030204" pitchFamily="34" charset="0"/>
            </a:endParaRPr>
          </a:p>
        </p:txBody>
      </p:sp>
      <p:pic>
        <p:nvPicPr>
          <p:cNvPr id="10" name="Picture 2" descr="T:\Transfer\Cindy\Old-Folders\For-Jane\PROTECT2\Validation\Test-of-Tests\No-Chemo\All\2015-08-31_TEAM-TOT_KM-Validation_DRFS_PAM50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5569" y="1802423"/>
            <a:ext cx="1917430" cy="2063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803300" y="1595655"/>
            <a:ext cx="14296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err="1" smtClean="0">
                <a:latin typeface="Arial Narrow" panose="020B0606020202030204" pitchFamily="34" charset="0"/>
              </a:rPr>
              <a:t>Prosigna</a:t>
            </a:r>
            <a:r>
              <a:rPr lang="en-CA" sz="1400" dirty="0" smtClean="0">
                <a:latin typeface="Arial Narrow" panose="020B0606020202030204" pitchFamily="34" charset="0"/>
              </a:rPr>
              <a:t>-</a:t>
            </a:r>
            <a:r>
              <a:rPr lang="en-CA" sz="1400" i="1" dirty="0" smtClean="0">
                <a:latin typeface="Arial Narrow" panose="020B0606020202030204" pitchFamily="34" charset="0"/>
              </a:rPr>
              <a:t>like</a:t>
            </a:r>
            <a:endParaRPr lang="en-CA" sz="1400" i="1" dirty="0">
              <a:latin typeface="Arial Narrow" panose="020B0606020202030204" pitchFamily="34" charset="0"/>
            </a:endParaRPr>
          </a:p>
        </p:txBody>
      </p:sp>
      <p:pic>
        <p:nvPicPr>
          <p:cNvPr id="12" name="Picture 2" descr="T:\Transfer\Cindy\Old-Folders\For-Jane\PROTECT2\Validation\Test-of-Tests\No-Chemo\All\2015-08-31_TEAM-TOT_KM-Validation_DRFS_IHC4-RNA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9961" y="4333696"/>
            <a:ext cx="1860678" cy="20028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5195918" y="4152701"/>
            <a:ext cx="10021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smtClean="0">
                <a:latin typeface="Arial Narrow" panose="020B0606020202030204" pitchFamily="34" charset="0"/>
              </a:rPr>
              <a:t>mRNA-IHC4</a:t>
            </a:r>
            <a:endParaRPr lang="en-CA" sz="1400" i="1" dirty="0">
              <a:latin typeface="Arial Narrow" panose="020B060602020203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262031" y="1596222"/>
            <a:ext cx="24600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dirty="0" smtClean="0">
                <a:latin typeface="Arial Narrow" panose="020B0606020202030204" pitchFamily="34" charset="0"/>
              </a:rPr>
              <a:t>Intrinsic Subtyping</a:t>
            </a:r>
            <a:endParaRPr lang="en-CA" sz="1400" dirty="0">
              <a:latin typeface="Arial Narrow" panose="020B0606020202030204" pitchFamily="34" charset="0"/>
            </a:endParaRPr>
          </a:p>
        </p:txBody>
      </p:sp>
      <p:pic>
        <p:nvPicPr>
          <p:cNvPr id="15" name="Picture 3" descr="T:\Transfer\Cindy\Old-Folders\For-Jane\PROTECT2\Validation\Test-of-Tests\No-Chemo\All\2015-08-31_TEAM-TOT_KM-Validation_DRFS_IHC4-Protein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5840" y="6889684"/>
            <a:ext cx="1891221" cy="18912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2920231" y="6581907"/>
            <a:ext cx="10358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smtClean="0">
                <a:latin typeface="Arial Narrow" panose="020B0606020202030204" pitchFamily="34" charset="0"/>
              </a:rPr>
              <a:t>Protein-IHC4</a:t>
            </a:r>
            <a:endParaRPr lang="en-CA" sz="1400" i="1" dirty="0">
              <a:latin typeface="Arial Narrow" panose="020B060602020203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0883" y="1474692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/>
              <a:t>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237398" y="1492598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B</a:t>
            </a:r>
            <a:endParaRPr lang="en-CA" sz="20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4554725" y="1479306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C</a:t>
            </a:r>
            <a:endParaRPr lang="en-CA" sz="20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126886" y="3932452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D</a:t>
            </a:r>
            <a:endParaRPr lang="en-CA" sz="20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2283401" y="3950358"/>
            <a:ext cx="309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E</a:t>
            </a:r>
            <a:endParaRPr lang="en-CA" sz="20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564343" y="3937066"/>
            <a:ext cx="3016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F</a:t>
            </a:r>
            <a:endParaRPr lang="en-CA" sz="20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2287408" y="6491134"/>
            <a:ext cx="3481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G</a:t>
            </a:r>
            <a:endParaRPr lang="en-CA" sz="2000" b="1" dirty="0"/>
          </a:p>
        </p:txBody>
      </p:sp>
    </p:spTree>
    <p:extLst>
      <p:ext uri="{BB962C8B-B14F-4D97-AF65-F5344CB8AC3E}">
        <p14:creationId xmlns:p14="http://schemas.microsoft.com/office/powerpoint/2010/main" val="21286339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1</Words>
  <Application>Microsoft Office PowerPoint</Application>
  <PresentationFormat>On-screen Show (4:3)</PresentationFormat>
  <Paragraphs>1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Bayani</dc:creator>
  <cp:lastModifiedBy>Jane Bayani</cp:lastModifiedBy>
  <cp:revision>12</cp:revision>
  <dcterms:created xsi:type="dcterms:W3CDTF">2016-05-05T14:49:32Z</dcterms:created>
  <dcterms:modified xsi:type="dcterms:W3CDTF">2016-07-29T18:37:29Z</dcterms:modified>
</cp:coreProperties>
</file>